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2153" autoAdjust="0"/>
  </p:normalViewPr>
  <p:slideViewPr>
    <p:cSldViewPr snapToGrid="0">
      <p:cViewPr>
        <p:scale>
          <a:sx n="100" d="100"/>
          <a:sy n="100" d="100"/>
        </p:scale>
        <p:origin x="540" y="120"/>
      </p:cViewPr>
      <p:guideLst/>
    </p:cSldViewPr>
  </p:slideViewPr>
  <p:notesTextViewPr>
    <p:cViewPr>
      <p:scale>
        <a:sx n="1" d="1"/>
        <a:sy n="1" d="1"/>
      </p:scale>
      <p:origin x="0" y="-216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261DE-3A8D-45EC-8FD2-1C007763B31B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C6999A-8DD1-44E8-A0D0-D26AA52D21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5196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  Morphological fusion assay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0,000 293T-ACE2-TMPRSS2 pre-incubated with 10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µ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 of individual drugs/solvents were co-cultured with 50,000 donor 293T cells transfected with an empty vector or the SARS-CoV-2 spike protein (SARS-2-S). Cells were fixed and stained with methylene blue. Bright-field images are of the same magnification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40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scale.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6999A-8DD1-44E8-A0D0-D26AA52D217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77112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8259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3259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2060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4870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926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2719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632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170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497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2265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2518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285AC-ED5D-49EF-9A1E-407AF7883F1F}" type="datetimeFigureOut">
              <a:rPr lang="en-GB" smtClean="0"/>
              <a:t>26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DCED50-FAC9-409E-8938-62701F7802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601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379" y="4066484"/>
            <a:ext cx="3500497" cy="2625373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5185" y="4066484"/>
            <a:ext cx="3543227" cy="265742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7823" y="856354"/>
            <a:ext cx="3499918" cy="262493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379" y="860516"/>
            <a:ext cx="3523059" cy="264229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839132" y="256457"/>
            <a:ext cx="26597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mpty vector-intact cells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tained blue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590889" y="-17053"/>
            <a:ext cx="44818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ARS-2-S solvent control-extensive fusion, syncytia disintegration, lost blue colour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70379" y="3481292"/>
            <a:ext cx="26949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fusion inhibitor restores blue colour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624444" y="3450723"/>
            <a:ext cx="28132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on-fusion inhibitor does not restore blue colour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383" y="-42561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635653" y="6274406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n-GB" sz="10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000" b="1" dirty="0">
              <a:solidFill>
                <a:schemeClr val="bg1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7637160" y="3125645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n-GB" sz="10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6583655" y="2098928"/>
            <a:ext cx="120220" cy="364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7877931" y="3369744"/>
            <a:ext cx="10929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855369" y="6523251"/>
            <a:ext cx="10929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474920" y="6397516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n-GB" sz="10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000" b="1" dirty="0">
              <a:solidFill>
                <a:schemeClr val="bg1"/>
              </a:solidFill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3694636" y="6646361"/>
            <a:ext cx="10929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646723" y="3134792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n-GB" sz="10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GB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000" b="1" dirty="0">
              <a:solidFill>
                <a:schemeClr val="bg1"/>
              </a:solidFill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>
            <a:off x="3866439" y="3383637"/>
            <a:ext cx="10929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87689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8</TotalTime>
  <Words>89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u-Wan Chan</dc:creator>
  <cp:lastModifiedBy>Shiu-Wan Chan</cp:lastModifiedBy>
  <cp:revision>14</cp:revision>
  <dcterms:created xsi:type="dcterms:W3CDTF">2022-10-09T14:52:14Z</dcterms:created>
  <dcterms:modified xsi:type="dcterms:W3CDTF">2022-10-26T16:22:34Z</dcterms:modified>
</cp:coreProperties>
</file>